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709" autoAdjust="0"/>
  </p:normalViewPr>
  <p:slideViewPr>
    <p:cSldViewPr snapToGrid="0" snapToObjects="1">
      <p:cViewPr>
        <p:scale>
          <a:sx n="90" d="100"/>
          <a:sy n="90" d="100"/>
        </p:scale>
        <p:origin x="-792" y="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9083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9650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9710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0279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239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0012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15447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6925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6501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410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7066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1478B-C7E9-6E41-8777-4C8E24FB97A1}" type="datetimeFigureOut">
              <a:rPr lang="en-US" smtClean="0"/>
              <a:t>3/10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91124-EF4A-7D47-BA36-B10D47DCB2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9572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167310"/>
              </p:ext>
            </p:extLst>
          </p:nvPr>
        </p:nvGraphicFramePr>
        <p:xfrm>
          <a:off x="806450" y="1377859"/>
          <a:ext cx="7531100" cy="2651797"/>
        </p:xfrm>
        <a:graphic>
          <a:graphicData uri="http://schemas.openxmlformats.org/drawingml/2006/table">
            <a:tbl>
              <a:tblPr/>
              <a:tblGrid>
                <a:gridCol w="927100"/>
                <a:gridCol w="825500"/>
                <a:gridCol w="957605"/>
                <a:gridCol w="693395"/>
                <a:gridCol w="825500"/>
                <a:gridCol w="825500"/>
                <a:gridCol w="825500"/>
                <a:gridCol w="825500"/>
                <a:gridCol w="825500"/>
              </a:tblGrid>
              <a:tr h="3048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FP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Focu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 Foci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Foci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Foci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Foci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(n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9050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CLING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e4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c10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RRESTED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se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c1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94887" y="1026000"/>
            <a:ext cx="40191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S3 Table: Data summary table for  figure 2F   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52781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115</Words>
  <Application>Microsoft Macintosh PowerPoint</Application>
  <PresentationFormat>On-screen Show (4:3)</PresentationFormat>
  <Paragraphs>10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ew York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rvashi  Rai</dc:creator>
  <cp:lastModifiedBy>Alan Tartakoff</cp:lastModifiedBy>
  <cp:revision>28</cp:revision>
  <dcterms:created xsi:type="dcterms:W3CDTF">2017-01-15T07:50:58Z</dcterms:created>
  <dcterms:modified xsi:type="dcterms:W3CDTF">2017-03-10T18:01:10Z</dcterms:modified>
</cp:coreProperties>
</file>